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6" r:id="rId2"/>
  </p:sldIdLst>
  <p:sldSz cx="146304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51"/>
    <p:restoredTop sz="96327"/>
  </p:normalViewPr>
  <p:slideViewPr>
    <p:cSldViewPr snapToGrid="0" snapToObjects="1">
      <p:cViewPr varScale="1">
        <p:scale>
          <a:sx n="82" d="100"/>
          <a:sy n="82" d="100"/>
        </p:scale>
        <p:origin x="158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28800" y="1496484"/>
            <a:ext cx="10972800" cy="3183467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4802717"/>
            <a:ext cx="10972800" cy="2207683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81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559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69880" y="486834"/>
            <a:ext cx="315468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05840" y="486834"/>
            <a:ext cx="928116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21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422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8220" y="2279652"/>
            <a:ext cx="12618720" cy="3803649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8220" y="6119285"/>
            <a:ext cx="12618720" cy="2000249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687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05840" y="2434167"/>
            <a:ext cx="621792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06640" y="2434167"/>
            <a:ext cx="621792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963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486834"/>
            <a:ext cx="1261872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7746" y="2241551"/>
            <a:ext cx="6189344" cy="1098549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7746" y="3340100"/>
            <a:ext cx="6189344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06640" y="2241551"/>
            <a:ext cx="6219826" cy="1098549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06640" y="3340100"/>
            <a:ext cx="6219826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59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977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279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609600"/>
            <a:ext cx="4718684" cy="21336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19826" y="1316567"/>
            <a:ext cx="7406640" cy="6498167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2743200"/>
            <a:ext cx="4718684" cy="5082117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948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609600"/>
            <a:ext cx="4718684" cy="21336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19826" y="1316567"/>
            <a:ext cx="7406640" cy="6498167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2743200"/>
            <a:ext cx="4718684" cy="5082117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864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05840" y="486834"/>
            <a:ext cx="1261872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5840" y="2434167"/>
            <a:ext cx="1261872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05840" y="8475134"/>
            <a:ext cx="329184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A54995-4F52-3C45-BE85-44A8B40CA14F}" type="datetimeFigureOut">
              <a:rPr lang="en-US" smtClean="0"/>
              <a:t>9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46320" y="8475134"/>
            <a:ext cx="493776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32720" y="8475134"/>
            <a:ext cx="329184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3E4AD4-A786-F64A-B7F6-77036377A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9215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>
            <a:extLst>
              <a:ext uri="{FF2B5EF4-FFF2-40B4-BE49-F238E27FC236}">
                <a16:creationId xmlns:a16="http://schemas.microsoft.com/office/drawing/2014/main" id="{8996523B-6973-9F4E-A0F4-87488C75BB7A}"/>
              </a:ext>
            </a:extLst>
          </p:cNvPr>
          <p:cNvSpPr/>
          <p:nvPr/>
        </p:nvSpPr>
        <p:spPr>
          <a:xfrm>
            <a:off x="325787" y="70410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G" sz="1159" b="1" dirty="0"/>
              <a:t>t0</a:t>
            </a:r>
            <a:endParaRPr lang="en-BG" sz="1159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F7D2FCFC-5385-3F41-A5D2-A63CE425B48F}"/>
              </a:ext>
            </a:extLst>
          </p:cNvPr>
          <p:cNvSpPr/>
          <p:nvPr/>
        </p:nvSpPr>
        <p:spPr>
          <a:xfrm>
            <a:off x="3828622" y="70410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BG" sz="1159" b="1" dirty="0"/>
              <a:t>t12</a:t>
            </a:r>
            <a:endParaRPr lang="en-BG" sz="1159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3E6EE1D-8182-A84C-A216-691A005F9930}"/>
              </a:ext>
            </a:extLst>
          </p:cNvPr>
          <p:cNvSpPr/>
          <p:nvPr/>
        </p:nvSpPr>
        <p:spPr>
          <a:xfrm>
            <a:off x="7454284" y="70410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59" b="1" dirty="0"/>
              <a:t>t</a:t>
            </a:r>
            <a:r>
              <a:rPr lang="en-BG" sz="1159" b="1" dirty="0"/>
              <a:t>48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CE25931A-E707-1B49-947A-A8924128003A}"/>
              </a:ext>
            </a:extLst>
          </p:cNvPr>
          <p:cNvSpPr/>
          <p:nvPr/>
        </p:nvSpPr>
        <p:spPr>
          <a:xfrm>
            <a:off x="11025349" y="70410"/>
            <a:ext cx="531184" cy="2707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59" b="1" dirty="0"/>
              <a:t>t</a:t>
            </a:r>
            <a:r>
              <a:rPr lang="en-BG" sz="1159" b="1" dirty="0"/>
              <a:t>96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563D9BC-9CC6-7248-913E-B1234A62A256}"/>
              </a:ext>
            </a:extLst>
          </p:cNvPr>
          <p:cNvSpPr txBox="1"/>
          <p:nvPr/>
        </p:nvSpPr>
        <p:spPr>
          <a:xfrm>
            <a:off x="325787" y="8405336"/>
            <a:ext cx="1401102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G" sz="14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Supplementary Figure </a:t>
            </a:r>
            <a:r>
              <a:rPr lang="en-US" sz="14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3</a:t>
            </a:r>
            <a:r>
              <a:rPr lang="en-BG" sz="14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. </a:t>
            </a:r>
            <a:r>
              <a:rPr lang="en-US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SingleR analysis of the data from the 4 time-points after MCF7 drug treatment. Top: SingleR Cluster Labels showing highest similarity with. Across the 4 datasets, cells with gene expression to the following cell types was found: CD4+ T-cells, Epithelial Cells, Macrophages, Endothelial cells, Erythrocytes, Keratinocytes, Plasma cells, and </a:t>
            </a:r>
            <a:r>
              <a:rPr lang="en-US" sz="14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Mesanglial</a:t>
            </a:r>
            <a:r>
              <a:rPr lang="en-US" sz="1400" dirty="0">
                <a:latin typeface="Arial Narrow" panose="020B0604020202020204" pitchFamily="34" charset="0"/>
                <a:cs typeface="Arial Narrow" panose="020B0604020202020204" pitchFamily="34" charset="0"/>
              </a:rPr>
              <a:t> cells. Bottom: SingleR gene expression heat maps.  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469BF993-2275-AF47-A2ED-1D1891E238E0}"/>
              </a:ext>
            </a:extLst>
          </p:cNvPr>
          <p:cNvSpPr/>
          <p:nvPr/>
        </p:nvSpPr>
        <p:spPr>
          <a:xfrm>
            <a:off x="1899576" y="2341087"/>
            <a:ext cx="40839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/>
              <a:t>a</a:t>
            </a:r>
            <a:endParaRPr lang="en-BG" sz="1600" dirty="0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B1F42D67-44AA-9749-AE7C-A67D58E56C2E}"/>
              </a:ext>
            </a:extLst>
          </p:cNvPr>
          <p:cNvSpPr/>
          <p:nvPr/>
        </p:nvSpPr>
        <p:spPr>
          <a:xfrm>
            <a:off x="1599260" y="4991748"/>
            <a:ext cx="23089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/>
              <a:t>b</a:t>
            </a:r>
            <a:endParaRPr lang="en-BG" sz="1600" dirty="0"/>
          </a:p>
        </p:txBody>
      </p:sp>
      <p:pic>
        <p:nvPicPr>
          <p:cNvPr id="70" name="Picture 69" descr="Chart, scatter chart&#10;&#10;Description automatically generated">
            <a:extLst>
              <a:ext uri="{FF2B5EF4-FFF2-40B4-BE49-F238E27FC236}">
                <a16:creationId xmlns:a16="http://schemas.microsoft.com/office/drawing/2014/main" id="{7D7DC845-83A1-EB43-899A-44DA9EBD7BE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574"/>
          <a:stretch/>
        </p:blipFill>
        <p:spPr>
          <a:xfrm>
            <a:off x="10751316" y="532897"/>
            <a:ext cx="3585495" cy="2945707"/>
          </a:xfrm>
          <a:prstGeom prst="rect">
            <a:avLst/>
          </a:prstGeom>
        </p:spPr>
      </p:pic>
      <p:pic>
        <p:nvPicPr>
          <p:cNvPr id="72" name="Picture 71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7217B75B-D2BD-514A-A907-A63FB184B46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111"/>
          <a:stretch/>
        </p:blipFill>
        <p:spPr>
          <a:xfrm>
            <a:off x="11025348" y="3748752"/>
            <a:ext cx="3444122" cy="4572000"/>
          </a:xfrm>
          <a:prstGeom prst="rect">
            <a:avLst/>
          </a:prstGeom>
        </p:spPr>
      </p:pic>
      <p:pic>
        <p:nvPicPr>
          <p:cNvPr id="74" name="Picture 73" descr="Chart, scatter chart&#10;&#10;Description automatically generated">
            <a:extLst>
              <a:ext uri="{FF2B5EF4-FFF2-40B4-BE49-F238E27FC236}">
                <a16:creationId xmlns:a16="http://schemas.microsoft.com/office/drawing/2014/main" id="{8C0F17E8-DFAC-714A-B760-E7F1F61E11D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8861"/>
          <a:stretch/>
        </p:blipFill>
        <p:spPr>
          <a:xfrm>
            <a:off x="7140424" y="532897"/>
            <a:ext cx="3636089" cy="2945707"/>
          </a:xfrm>
          <a:prstGeom prst="rect">
            <a:avLst/>
          </a:prstGeom>
        </p:spPr>
      </p:pic>
      <p:pic>
        <p:nvPicPr>
          <p:cNvPr id="76" name="Picture 75" descr="Chart, scatter chart&#10;&#10;Description automatically generated">
            <a:extLst>
              <a:ext uri="{FF2B5EF4-FFF2-40B4-BE49-F238E27FC236}">
                <a16:creationId xmlns:a16="http://schemas.microsoft.com/office/drawing/2014/main" id="{3E32D6D1-A2FD-594D-ABDF-2CE62AB964E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7934"/>
          <a:stretch/>
        </p:blipFill>
        <p:spPr>
          <a:xfrm>
            <a:off x="2317" y="532897"/>
            <a:ext cx="3601127" cy="2947077"/>
          </a:xfrm>
          <a:prstGeom prst="rect">
            <a:avLst/>
          </a:prstGeom>
        </p:spPr>
      </p:pic>
      <p:pic>
        <p:nvPicPr>
          <p:cNvPr id="78" name="Picture 77" descr="Graphical user interface&#10;&#10;Description automatically generated with low confidence">
            <a:extLst>
              <a:ext uri="{FF2B5EF4-FFF2-40B4-BE49-F238E27FC236}">
                <a16:creationId xmlns:a16="http://schemas.microsoft.com/office/drawing/2014/main" id="{A4152310-2E58-7D4F-9696-5C96772A552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8897"/>
          <a:stretch/>
        </p:blipFill>
        <p:spPr>
          <a:xfrm>
            <a:off x="407364" y="3748752"/>
            <a:ext cx="3601127" cy="4572000"/>
          </a:xfrm>
          <a:prstGeom prst="rect">
            <a:avLst/>
          </a:prstGeom>
        </p:spPr>
      </p:pic>
      <p:pic>
        <p:nvPicPr>
          <p:cNvPr id="82" name="Picture 81" descr="Chart, scatter chart&#10;&#10;Description automatically generated">
            <a:extLst>
              <a:ext uri="{FF2B5EF4-FFF2-40B4-BE49-F238E27FC236}">
                <a16:creationId xmlns:a16="http://schemas.microsoft.com/office/drawing/2014/main" id="{2F672F33-FF2A-C742-97DA-13CDCB509A4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7623"/>
          <a:stretch/>
        </p:blipFill>
        <p:spPr>
          <a:xfrm>
            <a:off x="3578247" y="532897"/>
            <a:ext cx="3587372" cy="2945707"/>
          </a:xfrm>
          <a:prstGeom prst="rect">
            <a:avLst/>
          </a:prstGeom>
        </p:spPr>
      </p:pic>
      <p:pic>
        <p:nvPicPr>
          <p:cNvPr id="84" name="Picture 83" descr="Graphical user interface&#10;&#10;Description automatically generated">
            <a:extLst>
              <a:ext uri="{FF2B5EF4-FFF2-40B4-BE49-F238E27FC236}">
                <a16:creationId xmlns:a16="http://schemas.microsoft.com/office/drawing/2014/main" id="{9BE1F0A6-23D3-BD4C-85CA-44798B1FA02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9769"/>
          <a:stretch/>
        </p:blipFill>
        <p:spPr>
          <a:xfrm>
            <a:off x="3948410" y="3748752"/>
            <a:ext cx="3587372" cy="4572000"/>
          </a:xfrm>
          <a:prstGeom prst="rect">
            <a:avLst/>
          </a:prstGeom>
        </p:spPr>
      </p:pic>
      <p:pic>
        <p:nvPicPr>
          <p:cNvPr id="86" name="Picture 85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5EB8EF37-6EF8-CD4D-988B-343FF59C09A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8889"/>
          <a:stretch/>
        </p:blipFill>
        <p:spPr>
          <a:xfrm>
            <a:off x="7489022" y="3748752"/>
            <a:ext cx="3636089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5384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</TotalTime>
  <Words>84</Words>
  <Application>Microsoft Macintosh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rvath, Anelia Dafinova</dc:creator>
  <cp:lastModifiedBy>Horvath, Anelia Dafinova</cp:lastModifiedBy>
  <cp:revision>17</cp:revision>
  <dcterms:created xsi:type="dcterms:W3CDTF">2021-06-11T17:52:30Z</dcterms:created>
  <dcterms:modified xsi:type="dcterms:W3CDTF">2021-09-26T13:23:11Z</dcterms:modified>
</cp:coreProperties>
</file>